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8" r:id="rId3"/>
    <p:sldId id="270" r:id="rId4"/>
    <p:sldId id="256" r:id="rId5"/>
    <p:sldId id="266" r:id="rId6"/>
    <p:sldId id="261" r:id="rId7"/>
    <p:sldId id="277" r:id="rId8"/>
    <p:sldId id="274" r:id="rId9"/>
    <p:sldId id="275" r:id="rId10"/>
    <p:sldId id="276" r:id="rId11"/>
    <p:sldId id="263" r:id="rId12"/>
    <p:sldId id="267" r:id="rId13"/>
    <p:sldId id="273" r:id="rId14"/>
    <p:sldId id="265" r:id="rId15"/>
    <p:sldId id="262" r:id="rId16"/>
    <p:sldId id="269" r:id="rId17"/>
    <p:sldId id="259" r:id="rId18"/>
    <p:sldId id="260" r:id="rId19"/>
    <p:sldId id="258" r:id="rId20"/>
    <p:sldId id="257" r:id="rId2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336" y="-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B HER2</a:t>
            </a:r>
            <a:endParaRPr lang="zh-CN" altLang="en-US" dirty="0"/>
          </a:p>
        </p:txBody>
      </p:sp>
      <p:pic>
        <p:nvPicPr>
          <p:cNvPr id="1026" name="Picture 2" descr="C:\Users\dell\Desktop\wb-bmc\P-HER2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1124744"/>
            <a:ext cx="8064896" cy="5340715"/>
          </a:xfrm>
          <a:prstGeom prst="rect">
            <a:avLst/>
          </a:prstGeom>
          <a:noFill/>
        </p:spPr>
      </p:pic>
      <p:sp>
        <p:nvSpPr>
          <p:cNvPr id="4" name="矩形 3"/>
          <p:cNvSpPr/>
          <p:nvPr/>
        </p:nvSpPr>
        <p:spPr>
          <a:xfrm>
            <a:off x="4139952" y="1988840"/>
            <a:ext cx="2448272" cy="72008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dell\Desktop\wb-bmc\Chk2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2492896"/>
            <a:ext cx="8280920" cy="3199444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</a:t>
            </a:r>
            <a:r>
              <a:rPr lang="en-US" altLang="zh-CN" dirty="0" smtClean="0"/>
              <a:t>Chk2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547664" y="1988840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CF7          </a:t>
            </a:r>
            <a:r>
              <a:rPr lang="en-US" altLang="zh-CN" dirty="0" smtClean="0"/>
              <a:t>     BT474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1259632" y="3429000"/>
            <a:ext cx="1440160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699792" y="3429000"/>
            <a:ext cx="1440160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dell\Desktop\wb-bmc\PARP(1号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1303011"/>
            <a:ext cx="8208911" cy="4108613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Cleaved PARP1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827584" y="2636912"/>
            <a:ext cx="1368152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2267744" y="2636912"/>
            <a:ext cx="1368152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3923928" y="2564904"/>
            <a:ext cx="1512168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5508104" y="2564904"/>
            <a:ext cx="1584176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TextBox 7"/>
          <p:cNvSpPr txBox="1"/>
          <p:nvPr/>
        </p:nvSpPr>
        <p:spPr>
          <a:xfrm>
            <a:off x="4139952" y="334397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E Cleaved PARP1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331640" y="980728"/>
            <a:ext cx="5904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CF7          BT474                          </a:t>
            </a:r>
            <a:r>
              <a:rPr lang="en-US" altLang="zh-CN" dirty="0" err="1" smtClean="0"/>
              <a:t>shNT</a:t>
            </a:r>
            <a:r>
              <a:rPr lang="en-US" altLang="zh-CN" dirty="0" smtClean="0"/>
              <a:t>                   shp53</a:t>
            </a:r>
            <a:endParaRPr lang="zh-CN" alt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Picture 3" descr="C:\Users\dell\Desktop\wb-bmc\B-Actin(PARP(1号)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7" y="1843268"/>
            <a:ext cx="8353010" cy="3169908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β-</a:t>
            </a:r>
            <a:r>
              <a:rPr lang="en-US" altLang="zh-CN" dirty="0" err="1" smtClean="0"/>
              <a:t>Actin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139952" y="334397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E β-</a:t>
            </a:r>
            <a:r>
              <a:rPr lang="en-US" altLang="zh-CN" dirty="0" err="1" smtClean="0"/>
              <a:t>Actin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331640" y="980728"/>
            <a:ext cx="5904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CF7          BT474                          </a:t>
            </a:r>
            <a:r>
              <a:rPr lang="en-US" altLang="zh-CN" dirty="0" err="1" smtClean="0"/>
              <a:t>shNT</a:t>
            </a:r>
            <a:r>
              <a:rPr lang="en-US" altLang="zh-CN" dirty="0" smtClean="0"/>
              <a:t>                   shp53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827584" y="2060848"/>
            <a:ext cx="1440160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2339752" y="2060848"/>
            <a:ext cx="1512168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4132372" y="1988840"/>
            <a:ext cx="1591756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5784766" y="1988840"/>
            <a:ext cx="1667554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dell\Desktop\wb-bmc\P-H2A.X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1560" y="1304171"/>
            <a:ext cx="7416824" cy="5553829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691680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E pH2AX S139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1763688" y="3789040"/>
            <a:ext cx="1152128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2915816" y="3789040"/>
            <a:ext cx="1080120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TextBox 7"/>
          <p:cNvSpPr txBox="1"/>
          <p:nvPr/>
        </p:nvSpPr>
        <p:spPr>
          <a:xfrm>
            <a:off x="4499992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pH2AX S139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4067944" y="3789040"/>
            <a:ext cx="1152128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5652120" y="3789040"/>
            <a:ext cx="1152128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2123728" y="1052736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NT</a:t>
            </a:r>
            <a:r>
              <a:rPr lang="en-US" altLang="zh-CN" dirty="0" smtClean="0"/>
              <a:t>     shp53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4283968" y="1052736"/>
            <a:ext cx="28803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/>
              <a:t>BT474                 MCF7</a:t>
            </a:r>
            <a:endParaRPr lang="zh-CN" alt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C:\Users\dell\Desktop\wb-bmc\P-H2AFX(1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5" y="1624262"/>
            <a:ext cx="8352928" cy="3671895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E pH2AX Y142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4139952" y="2996952"/>
            <a:ext cx="1512168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6084168" y="2996952"/>
            <a:ext cx="1440160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4572000" y="980728"/>
            <a:ext cx="2664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NT</a:t>
            </a:r>
            <a:r>
              <a:rPr lang="en-US" altLang="zh-CN" dirty="0" smtClean="0"/>
              <a:t>                         shp53</a:t>
            </a:r>
            <a:endParaRPr lang="zh-CN" alt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dell\Desktop\wb-bmc\P53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2348879"/>
            <a:ext cx="8352928" cy="3251295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E </a:t>
            </a:r>
            <a:r>
              <a:rPr lang="en-US" altLang="zh-CN" dirty="0" smtClean="0"/>
              <a:t>p53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292080" y="1988840"/>
            <a:ext cx="2664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 s</a:t>
            </a:r>
            <a:r>
              <a:rPr lang="en-US" altLang="zh-CN" dirty="0" smtClean="0"/>
              <a:t>hp53                 </a:t>
            </a:r>
            <a:r>
              <a:rPr lang="en-US" altLang="zh-CN" dirty="0" err="1" smtClean="0"/>
              <a:t>shNT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5220072" y="3356992"/>
            <a:ext cx="1368152" cy="36004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6660232" y="3356992"/>
            <a:ext cx="1368152" cy="36004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dell\Desktop\wb-bmc\ERBB2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2276872"/>
            <a:ext cx="8424936" cy="3754969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G pHER2 Y1221/122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1403648" y="3140968"/>
            <a:ext cx="1368152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2843808" y="3140968"/>
            <a:ext cx="1368152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4283968" y="3140968"/>
            <a:ext cx="1368152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5724128" y="3140968"/>
            <a:ext cx="1368152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TextBox 7"/>
          <p:cNvSpPr txBox="1"/>
          <p:nvPr/>
        </p:nvSpPr>
        <p:spPr>
          <a:xfrm>
            <a:off x="1475656" y="1835532"/>
            <a:ext cx="6336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  MCF7         MDA-MB-453         SKBR3              BT474</a:t>
            </a:r>
            <a:endParaRPr lang="zh-CN" altLang="en-US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dell\Desktop\wb-bmc\ERBB2(2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3296" y="2060848"/>
            <a:ext cx="8629184" cy="2952328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1475656" y="2492896"/>
            <a:ext cx="1440160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3491880" y="2564904"/>
            <a:ext cx="1512168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6012160" y="2636912"/>
            <a:ext cx="1584176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G HER2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75656" y="1484784"/>
            <a:ext cx="6336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KBR3                              MDA-MB-453                          MCF7</a:t>
            </a:r>
            <a:endParaRPr lang="zh-CN" altLang="en-US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dell\Desktop\wb-bmc\B-Actin(ERBB2(2)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9512" y="2204864"/>
            <a:ext cx="8822777" cy="3168352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899592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G β-</a:t>
            </a:r>
            <a:r>
              <a:rPr lang="en-US" altLang="zh-CN" dirty="0" err="1" smtClean="0"/>
              <a:t>Actin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75656" y="1484784"/>
            <a:ext cx="6336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KBR3                           MDA-MB-453                          MCF7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1331640" y="3068960"/>
            <a:ext cx="1584176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3419872" y="3068960"/>
            <a:ext cx="1584176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6012160" y="3068960"/>
            <a:ext cx="1584176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dell\Desktop\wb-bmc\ERBB2(1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51720" y="1988840"/>
            <a:ext cx="4117990" cy="3816424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G HER2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771800" y="119675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T474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2843808" y="2564904"/>
            <a:ext cx="1728192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B β-</a:t>
            </a:r>
            <a:r>
              <a:rPr lang="en-US" altLang="zh-CN" dirty="0" err="1" smtClean="0"/>
              <a:t>Actin</a:t>
            </a:r>
            <a:endParaRPr lang="zh-CN" altLang="en-US" dirty="0"/>
          </a:p>
        </p:txBody>
      </p:sp>
      <p:pic>
        <p:nvPicPr>
          <p:cNvPr id="2050" name="Picture 2" descr="C:\Users\dell\Desktop\wb-bmc\B-Actin(P-HER2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1052736"/>
            <a:ext cx="8424740" cy="5056619"/>
          </a:xfrm>
          <a:prstGeom prst="rect">
            <a:avLst/>
          </a:prstGeom>
          <a:noFill/>
        </p:spPr>
      </p:pic>
      <p:sp>
        <p:nvSpPr>
          <p:cNvPr id="4" name="矩形 3"/>
          <p:cNvSpPr/>
          <p:nvPr/>
        </p:nvSpPr>
        <p:spPr>
          <a:xfrm>
            <a:off x="4288633" y="3918046"/>
            <a:ext cx="2520280" cy="72008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dell\Desktop\wb-bmc\B-Actin(ERBB2(1)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67744" y="1484783"/>
            <a:ext cx="4824536" cy="4550707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899592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G β-</a:t>
            </a:r>
            <a:r>
              <a:rPr lang="en-US" altLang="zh-CN" dirty="0" err="1" smtClean="0"/>
              <a:t>Actin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3131840" y="2852936"/>
            <a:ext cx="2160240" cy="10801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TextBox 4"/>
          <p:cNvSpPr txBox="1"/>
          <p:nvPr/>
        </p:nvSpPr>
        <p:spPr>
          <a:xfrm>
            <a:off x="3203848" y="980728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T474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C:\Users\dell\Desktop\wb-bmc\P-H2AFX(2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79712" y="2204864"/>
            <a:ext cx="3600400" cy="3869589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 pH2AX S139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2555776" y="3645024"/>
            <a:ext cx="2016224" cy="115212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实验方法\WB\亿凡生物杨晓静20221215\原始图片\C-Caspase-3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3568" y="1340768"/>
            <a:ext cx="7753332" cy="4963431"/>
          </a:xfrm>
          <a:prstGeom prst="rect">
            <a:avLst/>
          </a:prstGeom>
          <a:noFill/>
        </p:spPr>
      </p:pic>
      <p:sp>
        <p:nvSpPr>
          <p:cNvPr id="5" name="矩形 4"/>
          <p:cNvSpPr/>
          <p:nvPr/>
        </p:nvSpPr>
        <p:spPr>
          <a:xfrm>
            <a:off x="1979712" y="3068960"/>
            <a:ext cx="1440160" cy="201622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 Cleaved </a:t>
            </a:r>
            <a:r>
              <a:rPr lang="en-US" altLang="zh-CN" dirty="0" err="1" smtClean="0"/>
              <a:t>caspased</a:t>
            </a:r>
            <a:r>
              <a:rPr lang="en-US" altLang="zh-CN" dirty="0" smtClean="0"/>
              <a:t> 3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C:\Users\dell\Desktop\wb-bmc\PARP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53870" y="1844825"/>
            <a:ext cx="8266601" cy="3258176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 Cleaved PARP1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1907704" y="2852936"/>
            <a:ext cx="1584176" cy="10081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99592" y="332656"/>
            <a:ext cx="331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 β-</a:t>
            </a:r>
            <a:r>
              <a:rPr lang="en-US" altLang="zh-CN" dirty="0" err="1" smtClean="0"/>
              <a:t>Actin</a:t>
            </a:r>
            <a:endParaRPr lang="zh-CN" altLang="en-US" dirty="0"/>
          </a:p>
        </p:txBody>
      </p:sp>
      <p:pic>
        <p:nvPicPr>
          <p:cNvPr id="2050" name="Picture 2" descr="D:\实验方法\WB\亿凡生物杨晓静20221215\原始图片\B-Actin(C-Caspase-3)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1412776"/>
            <a:ext cx="6984776" cy="5277045"/>
          </a:xfrm>
          <a:prstGeom prst="rect">
            <a:avLst/>
          </a:prstGeom>
          <a:noFill/>
        </p:spPr>
      </p:pic>
      <p:sp>
        <p:nvSpPr>
          <p:cNvPr id="4" name="矩形 3"/>
          <p:cNvSpPr/>
          <p:nvPr/>
        </p:nvSpPr>
        <p:spPr>
          <a:xfrm>
            <a:off x="1979712" y="2924944"/>
            <a:ext cx="1368152" cy="7920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C:\Users\dell\Desktop\wb-bmc\P-Chk1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2914" y="1844824"/>
            <a:ext cx="8702168" cy="3456384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</a:t>
            </a:r>
            <a:r>
              <a:rPr lang="en-US" altLang="zh-CN" dirty="0" smtClean="0"/>
              <a:t>pChk1 S345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652120" y="1484784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CF7          </a:t>
            </a:r>
            <a:r>
              <a:rPr lang="en-US" altLang="zh-CN" dirty="0" smtClean="0"/>
              <a:t>     BT474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364088" y="2924944"/>
            <a:ext cx="1440160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6876256" y="2924944"/>
            <a:ext cx="1512168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dell\Desktop\wb-bmc\Chk1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9512" y="2132856"/>
            <a:ext cx="8695844" cy="3553236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</a:t>
            </a:r>
            <a:r>
              <a:rPr lang="en-US" altLang="zh-CN" dirty="0" smtClean="0"/>
              <a:t>Chk1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508104" y="1700808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CF7          </a:t>
            </a:r>
            <a:r>
              <a:rPr lang="en-US" altLang="zh-CN" dirty="0" smtClean="0"/>
              <a:t>     BT474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076056" y="3140968"/>
            <a:ext cx="1440160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6588224" y="3140968"/>
            <a:ext cx="1440160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dell\Desktop\wb-bmc\P-Chk2(2)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628800"/>
            <a:ext cx="8784976" cy="4338703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55576" y="332656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D </a:t>
            </a:r>
            <a:r>
              <a:rPr lang="en-US" altLang="zh-CN" dirty="0" smtClean="0"/>
              <a:t>pChk2 T68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411760" y="1556792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CF7          </a:t>
            </a:r>
            <a:r>
              <a:rPr lang="en-US" altLang="zh-CN" dirty="0" smtClean="0"/>
              <a:t>     BT474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1979712" y="3068960"/>
            <a:ext cx="1440160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3491880" y="3068960"/>
            <a:ext cx="1512168" cy="4320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4</TotalTime>
  <Words>119</Words>
  <Application>Microsoft Office PowerPoint</Application>
  <PresentationFormat>全屏显示(4:3)</PresentationFormat>
  <Paragraphs>38</Paragraphs>
  <Slides>20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1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  <vt:lpstr>幻灯片 15</vt:lpstr>
      <vt:lpstr>幻灯片 16</vt:lpstr>
      <vt:lpstr>幻灯片 17</vt:lpstr>
      <vt:lpstr>幻灯片 18</vt:lpstr>
      <vt:lpstr>幻灯片 19</vt:lpstr>
      <vt:lpstr>幻灯片 2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dell</cp:lastModifiedBy>
  <cp:revision>44</cp:revision>
  <dcterms:created xsi:type="dcterms:W3CDTF">2023-02-05T02:51:17Z</dcterms:created>
  <dcterms:modified xsi:type="dcterms:W3CDTF">2023-02-11T03:51:09Z</dcterms:modified>
</cp:coreProperties>
</file>